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8" r:id="rId3"/>
    <p:sldId id="257" r:id="rId4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70" d="100"/>
          <a:sy n="70" d="100"/>
        </p:scale>
        <p:origin x="501" y="45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0DACDEBD-2BE4-D927-E52B-9BBFCFCDDECB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D34FD495-479B-0D22-BBCE-949965A6F793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EDF3A4D6-8D1F-C1C0-EC7B-C384F10CBF2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7ACE21-CE39-4EAE-A25B-3A47A38BCB2F}" type="datetimeFigureOut">
              <a:rPr lang="zh-CN" altLang="en-US" smtClean="0"/>
              <a:t>2025/12/16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FC9DA9F7-525D-FD51-D861-F2D721C006A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0F8470CB-6D37-F143-4BFA-AFAE38F5026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80BE64-BE44-402B-AD88-9CA33E2E155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82743409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F10342E9-6C20-F4CE-65FF-38FDFEEE5F3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F06B355E-1E7B-B8FA-73AA-10E585D337E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65EA3408-F005-24BC-425E-9217CFC9A24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7ACE21-CE39-4EAE-A25B-3A47A38BCB2F}" type="datetimeFigureOut">
              <a:rPr lang="zh-CN" altLang="en-US" smtClean="0"/>
              <a:t>2025/12/16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622580DD-EFD5-8724-28CA-4FF8A011748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60E76B19-7360-FE08-46D1-E5CD1DD8385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80BE64-BE44-402B-AD88-9CA33E2E155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24628752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id="{A66087F2-6E97-62B3-F404-B6AC401DFB6D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2CD8D342-D9D7-5FC2-0CA3-B463F9E4C605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CA381A9A-68E6-7532-8AD9-C5976FC82C6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7ACE21-CE39-4EAE-A25B-3A47A38BCB2F}" type="datetimeFigureOut">
              <a:rPr lang="zh-CN" altLang="en-US" smtClean="0"/>
              <a:t>2025/12/16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36C31E2B-682A-EAEC-E4BA-680B99B8ADF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ADEA354C-72D5-C123-C8FC-AD80EFF3CBB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80BE64-BE44-402B-AD88-9CA33E2E155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57101274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3132A294-308E-F96C-9A16-D4F79DC412D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B8B3A7CA-3EB8-4EBE-A376-ED3BE1693EF6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FBF35EAE-27F5-F1B0-388B-8052544036C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7ACE21-CE39-4EAE-A25B-3A47A38BCB2F}" type="datetimeFigureOut">
              <a:rPr lang="zh-CN" altLang="en-US" smtClean="0"/>
              <a:t>2025/12/16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D292501B-0848-D542-38E6-AA6A26413A8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9D604021-008B-2425-B6EA-B4EC7ADCBAC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80BE64-BE44-402B-AD88-9CA33E2E155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987753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B1CF7BAE-6C5B-1F62-03F5-904717D56E3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D004BBC2-F7DC-9F85-86C7-E40CEDE9FFA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AEA8E7DB-091F-54D0-F25A-BD64E73B0C1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7ACE21-CE39-4EAE-A25B-3A47A38BCB2F}" type="datetimeFigureOut">
              <a:rPr lang="zh-CN" altLang="en-US" smtClean="0"/>
              <a:t>2025/12/16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2756C46C-6413-FB6A-26DB-AD971172179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A49CC83E-3709-F34A-AC88-A544262C4CC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80BE64-BE44-402B-AD88-9CA33E2E155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6659312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843ABE2D-94AD-295F-1A88-BA795EA0B18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FC7C7CAB-ED17-0587-E6A2-5E5FE2E8B3AC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A8021B62-D2DB-16E6-D679-62B09F283DC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BD86A452-87D0-15A5-5C75-417B73332E7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7ACE21-CE39-4EAE-A25B-3A47A38BCB2F}" type="datetimeFigureOut">
              <a:rPr lang="zh-CN" altLang="en-US" smtClean="0"/>
              <a:t>2025/12/16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AE164AF5-7EFF-8DB5-5464-BA561925993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6C112DBC-DB01-0DF2-35F2-A306B287703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80BE64-BE44-402B-AD88-9CA33E2E155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14929877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5BAF96E6-19D9-FFA6-82BB-EDE27E688E2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F6C37B62-1FDC-2B9E-64FE-A361A106259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7987DE45-0659-2DBE-7773-604C97C3118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id="{AC55959A-81F2-9C9A-8D67-543725E790BB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id="{83FD5AA2-538B-DC05-B498-6BDB4707EA7F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id="{C2227183-5C24-6002-A31E-BDC68598E0D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7ACE21-CE39-4EAE-A25B-3A47A38BCB2F}" type="datetimeFigureOut">
              <a:rPr lang="zh-CN" altLang="en-US" smtClean="0"/>
              <a:t>2025/12/16</a:t>
            </a:fld>
            <a:endParaRPr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id="{AA7B90C6-CE31-B347-C614-2920E59887E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id="{F5402FC4-CB45-4351-C2A2-04768A7AA85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80BE64-BE44-402B-AD88-9CA33E2E155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65136230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03A64835-7E50-4457-96F4-4D705103C5F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5AF50A21-7B20-AB7F-A79C-DA16CA4B3D3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7ACE21-CE39-4EAE-A25B-3A47A38BCB2F}" type="datetimeFigureOut">
              <a:rPr lang="zh-CN" altLang="en-US" smtClean="0"/>
              <a:t>2025/12/16</a:t>
            </a:fld>
            <a:endParaRPr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98E4D1C3-D295-8AEB-4864-AA9305E08FF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34383CC6-F20F-377D-275A-25C354A2391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80BE64-BE44-402B-AD88-9CA33E2E155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17954914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id="{FAD18612-3B5D-DE2D-CA48-7A8231FD67E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7ACE21-CE39-4EAE-A25B-3A47A38BCB2F}" type="datetimeFigureOut">
              <a:rPr lang="zh-CN" altLang="en-US" smtClean="0"/>
              <a:t>2025/12/16</a:t>
            </a:fld>
            <a:endParaRPr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id="{D6737FCB-E85A-19F3-59C1-A029354639B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16C1E2BE-7B9B-01E9-9A3A-7EE75425B0E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80BE64-BE44-402B-AD88-9CA33E2E155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74251995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AD7352F9-CFD3-522B-9B65-B0013B17D5E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1EB60E20-B595-D594-DF66-1066AF96972B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CD34B4EA-0D8B-5162-56F8-861630AFF8A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8E131686-C199-486B-009C-D75FA238E53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7ACE21-CE39-4EAE-A25B-3A47A38BCB2F}" type="datetimeFigureOut">
              <a:rPr lang="zh-CN" altLang="en-US" smtClean="0"/>
              <a:t>2025/12/16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1EB123BE-C06B-8D46-E84A-512409FD5D2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A054E7E4-00D2-EFC5-952A-CC7C08FB0D1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80BE64-BE44-402B-AD88-9CA33E2E155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94560680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3C8F82CB-A5B0-40CC-E0B1-B1F89EDE23C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id="{BFFE9860-51D7-F641-AE41-ED366862ADD8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542161C8-336B-51C1-3EF8-81113372EAD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C7FD0118-9539-68A0-5424-AC8EC721D28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7ACE21-CE39-4EAE-A25B-3A47A38BCB2F}" type="datetimeFigureOut">
              <a:rPr lang="zh-CN" altLang="en-US" smtClean="0"/>
              <a:t>2025/12/16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5C76EF35-7CB1-6439-FFCF-52F362E5F74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65F915EA-6747-F5E2-67BE-A82219ED090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80BE64-BE44-402B-AD88-9CA33E2E155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55089121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id="{3CBCF4B5-576A-7BA5-3F1D-928EBC37B07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BF2FE258-89DA-390C-9BF2-213BCFAFBB6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D46414F8-C390-83A6-E17C-6DD9E02A32F2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C7ACE21-CE39-4EAE-A25B-3A47A38BCB2F}" type="datetimeFigureOut">
              <a:rPr lang="zh-CN" altLang="en-US" smtClean="0"/>
              <a:t>2025/12/16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1FDA3BD9-CFFF-960C-66C7-6A25E9DA5B07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D53BF336-30D1-D00D-E1C6-2C53E11AFE11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780BE64-BE44-402B-AD88-9CA33E2E155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8560886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图片 3">
            <a:extLst>
              <a:ext uri="{FF2B5EF4-FFF2-40B4-BE49-F238E27FC236}">
                <a16:creationId xmlns:a16="http://schemas.microsoft.com/office/drawing/2014/main" id="{1C8448F5-D593-AF58-097B-A8C00170F22C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5063" y="268852"/>
            <a:ext cx="5841242" cy="5924688"/>
          </a:xfrm>
          <a:prstGeom prst="rect">
            <a:avLst/>
          </a:prstGeom>
        </p:spPr>
      </p:pic>
      <p:pic>
        <p:nvPicPr>
          <p:cNvPr id="5" name="图片 4">
            <a:extLst>
              <a:ext uri="{FF2B5EF4-FFF2-40B4-BE49-F238E27FC236}">
                <a16:creationId xmlns:a16="http://schemas.microsoft.com/office/drawing/2014/main" id="{B306369F-813E-B232-104B-CC50D3F14FBA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164237" y="268852"/>
            <a:ext cx="5668370" cy="4464469"/>
          </a:xfrm>
          <a:prstGeom prst="rect">
            <a:avLst/>
          </a:prstGeom>
        </p:spPr>
      </p:pic>
      <p:sp>
        <p:nvSpPr>
          <p:cNvPr id="6" name="文本框 5">
            <a:extLst>
              <a:ext uri="{FF2B5EF4-FFF2-40B4-BE49-F238E27FC236}">
                <a16:creationId xmlns:a16="http://schemas.microsoft.com/office/drawing/2014/main" id="{2DC6B360-70B3-670F-49DE-0620EDE0283B}"/>
              </a:ext>
            </a:extLst>
          </p:cNvPr>
          <p:cNvSpPr txBox="1"/>
          <p:nvPr/>
        </p:nvSpPr>
        <p:spPr>
          <a:xfrm>
            <a:off x="6164237" y="4862975"/>
            <a:ext cx="5531893" cy="147732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/>
              <a:t>Supplementary Figure 1 | Flow Cytometric Analysis.</a:t>
            </a:r>
            <a:br>
              <a:rPr lang="en-US" altLang="zh-CN" dirty="0"/>
            </a:br>
            <a:r>
              <a:rPr lang="en-US" altLang="zh-CN" dirty="0"/>
              <a:t>This cell population is positive for CD34, CD13, CD33, and CD117; partially positive for CD36; and negative for HLA-DR, CD3, CD4, CD5, CD7, CD8, CD10, CD11b, CD14, CD15, CD16, CD19, CD20, CD56, and CD64.</a:t>
            </a: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325554966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图片 3">
            <a:extLst>
              <a:ext uri="{FF2B5EF4-FFF2-40B4-BE49-F238E27FC236}">
                <a16:creationId xmlns:a16="http://schemas.microsoft.com/office/drawing/2014/main" id="{C1CD5B37-7300-4C4A-1E63-8D1F24E5BDFA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511630" y="476273"/>
            <a:ext cx="6570956" cy="4185248"/>
          </a:xfrm>
          <a:prstGeom prst="rect">
            <a:avLst/>
          </a:prstGeom>
        </p:spPr>
      </p:pic>
      <p:sp>
        <p:nvSpPr>
          <p:cNvPr id="6" name="文本框 5">
            <a:extLst>
              <a:ext uri="{FF2B5EF4-FFF2-40B4-BE49-F238E27FC236}">
                <a16:creationId xmlns:a16="http://schemas.microsoft.com/office/drawing/2014/main" id="{FFB39764-633A-591D-0A8C-57CA2DE3A4F7}"/>
              </a:ext>
            </a:extLst>
          </p:cNvPr>
          <p:cNvSpPr txBox="1"/>
          <p:nvPr/>
        </p:nvSpPr>
        <p:spPr>
          <a:xfrm>
            <a:off x="2650447" y="4969512"/>
            <a:ext cx="7000290" cy="120032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b="1" i="0" dirty="0">
                <a:effectLst/>
                <a:latin typeface="quote-cjk-patch"/>
              </a:rPr>
              <a:t>Supplementary Figure 2 | Bone Marrow Cell Karyotype Analysis.</a:t>
            </a:r>
            <a:br>
              <a:rPr lang="en-US" altLang="zh-CN" dirty="0"/>
            </a:br>
            <a:r>
              <a:rPr lang="en-US" altLang="zh-CN" b="0" i="0" dirty="0">
                <a:effectLst/>
                <a:latin typeface="quote-cjk-patch"/>
              </a:rPr>
              <a:t>The karyotype is 44,X,-X,-6[1]. Microscopic examination revealed only one incomplete metaphase spread; the missing chromosomes are considered to be randomly lost.</a:t>
            </a: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841923060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图片 3">
            <a:extLst>
              <a:ext uri="{FF2B5EF4-FFF2-40B4-BE49-F238E27FC236}">
                <a16:creationId xmlns:a16="http://schemas.microsoft.com/office/drawing/2014/main" id="{DB50367E-38BD-7EF6-2D1B-349E882D9981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187525" y="1451758"/>
            <a:ext cx="9144000" cy="1386089"/>
          </a:xfrm>
          <a:prstGeom prst="rect">
            <a:avLst/>
          </a:prstGeom>
        </p:spPr>
      </p:pic>
      <p:sp>
        <p:nvSpPr>
          <p:cNvPr id="6" name="文本框 5">
            <a:extLst>
              <a:ext uri="{FF2B5EF4-FFF2-40B4-BE49-F238E27FC236}">
                <a16:creationId xmlns:a16="http://schemas.microsoft.com/office/drawing/2014/main" id="{5B9E5273-B550-A593-306C-A2B7D68CD05A}"/>
              </a:ext>
            </a:extLst>
          </p:cNvPr>
          <p:cNvSpPr txBox="1"/>
          <p:nvPr/>
        </p:nvSpPr>
        <p:spPr>
          <a:xfrm>
            <a:off x="1369893" y="3576938"/>
            <a:ext cx="8279073" cy="120032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b="1" i="0" dirty="0">
                <a:effectLst/>
                <a:latin typeface="quote-cjk-patch"/>
              </a:rPr>
              <a:t>Supplementary Figure 3 | Molecular Pathology Report.</a:t>
            </a:r>
            <a:br>
              <a:rPr lang="en-US" altLang="zh-CN" dirty="0"/>
            </a:br>
            <a:r>
              <a:rPr lang="en-US" altLang="zh-CN" b="0" i="0" dirty="0">
                <a:effectLst/>
                <a:latin typeface="quote-cjk-patch"/>
              </a:rPr>
              <a:t>A FLT3-ITD mutation was detected. This variant was verified as an approximately 47-base pair tandem duplication in Exon 14. The allelic ratio (AR) was categorized as HIGH (approximately 0.78).</a:t>
            </a: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229953502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1</TotalTime>
  <Words>148</Words>
  <Application>Microsoft Office PowerPoint</Application>
  <PresentationFormat>宽屏</PresentationFormat>
  <Paragraphs>3</Paragraphs>
  <Slides>3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3</vt:i4>
      </vt:variant>
    </vt:vector>
  </HeadingPairs>
  <TitlesOfParts>
    <vt:vector size="8" baseType="lpstr">
      <vt:lpstr>quote-cjk-patch</vt:lpstr>
      <vt:lpstr>等线</vt:lpstr>
      <vt:lpstr>等线 Light</vt:lpstr>
      <vt:lpstr>Arial</vt:lpstr>
      <vt:lpstr>Office 主题​​</vt:lpstr>
      <vt:lpstr>PowerPoint 演示文稿</vt:lpstr>
      <vt:lpstr>PowerPoint 演示文稿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Yuan Cao</dc:creator>
  <cp:lastModifiedBy>Yuan Cao</cp:lastModifiedBy>
  <cp:revision>1</cp:revision>
  <dcterms:created xsi:type="dcterms:W3CDTF">2025-12-16T02:44:02Z</dcterms:created>
  <dcterms:modified xsi:type="dcterms:W3CDTF">2025-12-16T02:55:04Z</dcterms:modified>
</cp:coreProperties>
</file>